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9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628" y="-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How%20Often%20is%20your%20shoulder%20Painful%20during%20activity%20for%20pairing%20T%202%20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How%20Often%20is%20your%20shoulder%20Painful%20during%20activity%20for%20pairing%20T%202%20a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H:\PhD\PhD%20-%20Working%20folder\Working\Pain\Done\Pain%20-%20How%20much%20difficulty%20do%20you%20have%20with%20activites%20above%20your%20hea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AU"/>
  <c:chart>
    <c:autoTitleDeleted val="1"/>
    <c:plotArea>
      <c:layout>
        <c:manualLayout>
          <c:layoutTarget val="inner"/>
          <c:xMode val="edge"/>
          <c:yMode val="edge"/>
          <c:x val="0.20017836832895883"/>
          <c:y val="2.6392590467684874E-2"/>
          <c:w val="0.73274518810148781"/>
          <c:h val="0.8107383742948554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6.3299759980733242E-2</c:v>
                  </c:pt>
                  <c:pt idx="1">
                    <c:v>0.15443124735353028</c:v>
                  </c:pt>
                  <c:pt idx="2">
                    <c:v>0.1251159017402447</c:v>
                  </c:pt>
                  <c:pt idx="3">
                    <c:v>0.15163680597197118</c:v>
                  </c:pt>
                  <c:pt idx="4">
                    <c:v>0.16669566982823084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6.3299759980733242E-2</c:v>
                  </c:pt>
                  <c:pt idx="1">
                    <c:v>0.15443124735353028</c:v>
                  </c:pt>
                  <c:pt idx="2">
                    <c:v>0.1251159017402447</c:v>
                  </c:pt>
                  <c:pt idx="3">
                    <c:v>0.15163680597197118</c:v>
                  </c:pt>
                  <c:pt idx="4">
                    <c:v>0.16669566982823084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6825396825396828</c:v>
                </c:pt>
                <c:pt idx="1">
                  <c:v>2.9482758620689653</c:v>
                </c:pt>
                <c:pt idx="2">
                  <c:v>3.1785714285714288</c:v>
                </c:pt>
                <c:pt idx="3">
                  <c:v>2.7068965517241383</c:v>
                </c:pt>
                <c:pt idx="4">
                  <c:v>2.0769230769230771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0682897256143144</c:v>
                  </c:pt>
                  <c:pt idx="1">
                    <c:v>0.14522347349741141</c:v>
                  </c:pt>
                  <c:pt idx="2">
                    <c:v>0.14913118071475204</c:v>
                  </c:pt>
                  <c:pt idx="3">
                    <c:v>0.17457870326541047</c:v>
                  </c:pt>
                  <c:pt idx="4">
                    <c:v>0.20602813225724911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0682897256143144</c:v>
                  </c:pt>
                  <c:pt idx="1">
                    <c:v>0.14522347349741141</c:v>
                  </c:pt>
                  <c:pt idx="2">
                    <c:v>0.14913118071475204</c:v>
                  </c:pt>
                  <c:pt idx="3">
                    <c:v>0.17457870326541047</c:v>
                  </c:pt>
                  <c:pt idx="4">
                    <c:v>0.20602813225724911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6</c:v>
                </c:pt>
                <c:pt idx="1">
                  <c:v>3.1186440677966107</c:v>
                </c:pt>
                <c:pt idx="2">
                  <c:v>2.9807692307692308</c:v>
                </c:pt>
                <c:pt idx="3">
                  <c:v>2.442307692307693</c:v>
                </c:pt>
                <c:pt idx="4">
                  <c:v>1.5918367346938775</c:v>
                </c:pt>
              </c:numCache>
            </c:numRef>
          </c:val>
        </c:ser>
        <c:marker val="1"/>
        <c:axId val="81699584"/>
        <c:axId val="81701504"/>
      </c:lineChart>
      <c:catAx>
        <c:axId val="8169958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 Cuff Repair</a:t>
                </a:r>
              </a:p>
            </c:rich>
          </c:tx>
          <c:layout/>
        </c:title>
        <c:numFmt formatCode="General" sourceLinked="1"/>
        <c:maj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1701504"/>
        <c:crosses val="autoZero"/>
        <c:auto val="1"/>
        <c:lblAlgn val="ctr"/>
        <c:lblOffset val="100"/>
      </c:catAx>
      <c:valAx>
        <c:axId val="81701504"/>
        <c:scaling>
          <c:orientation val="minMax"/>
          <c:max val="4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Frequency of Pain during Activities</a:t>
                </a:r>
              </a:p>
            </c:rich>
          </c:tx>
          <c:layout>
            <c:manualLayout>
              <c:xMode val="edge"/>
              <c:yMode val="edge"/>
              <c:x val="3.888888888888889E-2"/>
              <c:y val="5.7727200786822988E-2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1699584"/>
        <c:crosses val="autoZero"/>
        <c:crossBetween val="between"/>
        <c:majorUnit val="1"/>
        <c:minorUnit val="1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81347911198600176"/>
          <c:y val="0.64955183026781393"/>
          <c:w val="0.1351319991251094"/>
          <c:h val="0.11366751642040766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autoTitleDeleted val="1"/>
    <c:plotArea>
      <c:layout>
        <c:manualLayout>
          <c:layoutTarget val="inner"/>
          <c:xMode val="edge"/>
          <c:yMode val="edge"/>
          <c:x val="0.20017836832895877"/>
          <c:y val="2.639259046768487E-2"/>
          <c:w val="0.73274518810148803"/>
          <c:h val="0.81073837429485562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6.3299759980733283E-2</c:v>
                  </c:pt>
                  <c:pt idx="1">
                    <c:v>0.15443124735353037</c:v>
                  </c:pt>
                  <c:pt idx="2">
                    <c:v>0.1251159017402447</c:v>
                  </c:pt>
                  <c:pt idx="3">
                    <c:v>0.15163680597197121</c:v>
                  </c:pt>
                  <c:pt idx="4">
                    <c:v>0.16669566982823084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6.3299759980733283E-2</c:v>
                  </c:pt>
                  <c:pt idx="1">
                    <c:v>0.15443124735353037</c:v>
                  </c:pt>
                  <c:pt idx="2">
                    <c:v>0.1251159017402447</c:v>
                  </c:pt>
                  <c:pt idx="3">
                    <c:v>0.15163680597197121</c:v>
                  </c:pt>
                  <c:pt idx="4">
                    <c:v>0.16669566982823084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6825396825396832</c:v>
                </c:pt>
                <c:pt idx="1">
                  <c:v>2.9482758620689653</c:v>
                </c:pt>
                <c:pt idx="2">
                  <c:v>3.1785714285714302</c:v>
                </c:pt>
                <c:pt idx="3">
                  <c:v>2.7068965517241392</c:v>
                </c:pt>
                <c:pt idx="4">
                  <c:v>2.0769230769230771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0682897256143151</c:v>
                  </c:pt>
                  <c:pt idx="1">
                    <c:v>0.14522347349741149</c:v>
                  </c:pt>
                  <c:pt idx="2">
                    <c:v>0.14913118071475204</c:v>
                  </c:pt>
                  <c:pt idx="3">
                    <c:v>0.17457870326541047</c:v>
                  </c:pt>
                  <c:pt idx="4">
                    <c:v>0.20602813225724922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0682897256143151</c:v>
                  </c:pt>
                  <c:pt idx="1">
                    <c:v>0.14522347349741149</c:v>
                  </c:pt>
                  <c:pt idx="2">
                    <c:v>0.14913118071475204</c:v>
                  </c:pt>
                  <c:pt idx="3">
                    <c:v>0.17457870326541047</c:v>
                  </c:pt>
                  <c:pt idx="4">
                    <c:v>0.20602813225724922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6</c:v>
                </c:pt>
                <c:pt idx="1">
                  <c:v>3.1186440677966112</c:v>
                </c:pt>
                <c:pt idx="2">
                  <c:v>2.9807692307692308</c:v>
                </c:pt>
                <c:pt idx="3">
                  <c:v>2.4423076923076943</c:v>
                </c:pt>
                <c:pt idx="4">
                  <c:v>1.5918367346938775</c:v>
                </c:pt>
              </c:numCache>
            </c:numRef>
          </c:val>
        </c:ser>
        <c:marker val="1"/>
        <c:axId val="82841984"/>
        <c:axId val="82843904"/>
      </c:lineChart>
      <c:catAx>
        <c:axId val="8284198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 Cuff Repair</a:t>
                </a:r>
              </a:p>
            </c:rich>
          </c:tx>
          <c:layout/>
        </c:title>
        <c:numFmt formatCode="General" sourceLinked="1"/>
        <c:maj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2843904"/>
        <c:crosses val="autoZero"/>
        <c:auto val="1"/>
        <c:lblAlgn val="ctr"/>
        <c:lblOffset val="100"/>
      </c:catAx>
      <c:valAx>
        <c:axId val="82843904"/>
        <c:scaling>
          <c:orientation val="minMax"/>
          <c:max val="4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Frequency of Pain during Activities</a:t>
                </a:r>
              </a:p>
            </c:rich>
          </c:tx>
          <c:layout>
            <c:manualLayout>
              <c:xMode val="edge"/>
              <c:yMode val="edge"/>
              <c:x val="3.888888888888889E-2"/>
              <c:y val="5.7727200786822981E-2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2841984"/>
        <c:crosses val="autoZero"/>
        <c:crossBetween val="between"/>
        <c:majorUnit val="1"/>
        <c:minorUnit val="1"/>
      </c:valAx>
      <c:spPr>
        <a:ln>
          <a:noFill/>
        </a:ln>
      </c:spPr>
    </c:plotArea>
    <c:legend>
      <c:legendPos val="r"/>
      <c:layout>
        <c:manualLayout>
          <c:xMode val="edge"/>
          <c:yMode val="edge"/>
          <c:x val="0.8634791119860018"/>
          <c:y val="0.68544497609007826"/>
          <c:w val="0.1351319991251094"/>
          <c:h val="0.11366751642040765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autoTitleDeleted val="1"/>
    <c:plotArea>
      <c:layout>
        <c:manualLayout>
          <c:layoutTarget val="inner"/>
          <c:xMode val="edge"/>
          <c:yMode val="edge"/>
          <c:x val="0.21927756020740619"/>
          <c:y val="0.19503178769320509"/>
          <c:w val="0.70073852498521849"/>
          <c:h val="0.67244065325167857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4</c:v>
                  </c:pt>
                  <c:pt idx="2">
                    <c:v>0.18538488297990471</c:v>
                  </c:pt>
                  <c:pt idx="3">
                    <c:v>0.16524355544590549</c:v>
                  </c:pt>
                  <c:pt idx="4">
                    <c:v>0.14292949787065543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4</c:v>
                  </c:pt>
                  <c:pt idx="2">
                    <c:v>0.18538488297990471</c:v>
                  </c:pt>
                  <c:pt idx="3">
                    <c:v>0.16524355544590549</c:v>
                  </c:pt>
                  <c:pt idx="4">
                    <c:v>0.14292949787065543</c:v>
                  </c:pt>
                </c:numCache>
              </c:numRef>
            </c:minus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1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0163934426229546</c:v>
                </c:pt>
                <c:pt idx="1">
                  <c:v>3.6744186046511627</c:v>
                </c:pt>
                <c:pt idx="2">
                  <c:v>2.7924528301886746</c:v>
                </c:pt>
                <c:pt idx="3">
                  <c:v>2.1851851851851847</c:v>
                </c:pt>
                <c:pt idx="4">
                  <c:v>1.7358490566037739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4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1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4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1</c:v>
                  </c:pt>
                </c:numCache>
              </c:numRef>
            </c:minus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0517241379310351</c:v>
                </c:pt>
                <c:pt idx="1">
                  <c:v>3.6666666666666665</c:v>
                </c:pt>
                <c:pt idx="2">
                  <c:v>3.0181818181818212</c:v>
                </c:pt>
                <c:pt idx="3">
                  <c:v>2.2549019607843181</c:v>
                </c:pt>
                <c:pt idx="4">
                  <c:v>1.6470588235294121</c:v>
                </c:pt>
              </c:numCache>
            </c:numRef>
          </c:val>
        </c:ser>
        <c:marker val="1"/>
        <c:axId val="82084224"/>
        <c:axId val="82085760"/>
      </c:lineChart>
      <c:catAx>
        <c:axId val="8208422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 baseline="0"/>
                </a:pPr>
                <a:r>
                  <a:rPr lang="en-US" sz="2000" baseline="0" dirty="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5077073790657581"/>
              <c:y val="0.919879556722077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 baseline="0"/>
            </a:pPr>
            <a:endParaRPr lang="en-US"/>
          </a:p>
        </c:txPr>
        <c:crossAx val="82085760"/>
        <c:crosses val="autoZero"/>
        <c:auto val="1"/>
        <c:lblAlgn val="ctr"/>
        <c:lblOffset val="100"/>
      </c:catAx>
      <c:valAx>
        <c:axId val="82085760"/>
        <c:scaling>
          <c:orientation val="minMax"/>
          <c:max val="4"/>
        </c:scaling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2000" b="1" i="0" baseline="0" dirty="0"/>
                  <a:t>Difficulty with Overhead </a:t>
                </a:r>
                <a:r>
                  <a:rPr lang="en-AU" sz="2000" b="1" i="0" baseline="0" dirty="0" smtClean="0"/>
                  <a:t>Activities</a:t>
                </a:r>
                <a:endParaRPr lang="en-AU" sz="2000" baseline="0" dirty="0"/>
              </a:p>
            </c:rich>
          </c:tx>
          <c:layout>
            <c:manualLayout>
              <c:xMode val="edge"/>
              <c:yMode val="edge"/>
              <c:x val="4.707514635965631E-2"/>
              <c:y val="0.24596704578594369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crossAx val="82084224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79874455224257579"/>
          <c:y val="0.16419510061242373"/>
          <c:w val="0.13476823983733371"/>
          <c:h val="9.3832020997375518E-2"/>
        </c:manualLayout>
      </c:layout>
      <c:txPr>
        <a:bodyPr/>
        <a:lstStyle/>
        <a:p>
          <a:pPr>
            <a:defRPr sz="1600" baseline="0"/>
          </a:pPr>
          <a:endParaRPr lang="en-US"/>
        </a:p>
      </c:txPr>
    </c:legend>
    <c:plotVisOnly val="1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51</cdr:x>
      <cdr:y>0.12201</cdr:y>
    </cdr:from>
    <cdr:to>
      <cdr:x>0.22248</cdr:x>
      <cdr:y>0.91991</cdr:y>
    </cdr:to>
    <cdr:grpSp>
      <cdr:nvGrpSpPr>
        <cdr:cNvPr id="9" name="Group 8"/>
        <cdr:cNvGrpSpPr/>
      </cdr:nvGrpSpPr>
      <cdr:grpSpPr>
        <a:xfrm xmlns:a="http://schemas.openxmlformats.org/drawingml/2006/main">
          <a:off x="780255" y="836745"/>
          <a:ext cx="1259593" cy="5471998"/>
          <a:chOff x="5508104" y="980728"/>
          <a:chExt cx="1259632" cy="5400600"/>
        </a:xfrm>
      </cdr:grpSpPr>
      <cdr:sp macro="" textlink="">
        <cdr:nvSpPr>
          <cdr:cNvPr id="10" name="Rectangle 9"/>
          <cdr:cNvSpPr/>
        </cdr:nvSpPr>
        <cdr:spPr>
          <a:xfrm xmlns:a="http://schemas.openxmlformats.org/drawingml/2006/main">
            <a:off x="5508104" y="980728"/>
            <a:ext cx="1112447" cy="5400600"/>
          </a:xfrm>
          <a:prstGeom xmlns:a="http://schemas.openxmlformats.org/drawingml/2006/main" prst="rect">
            <a:avLst/>
          </a:prstGeom>
          <a:solidFill xmlns:a="http://schemas.openxmlformats.org/drawingml/2006/main">
            <a:sysClr val="window" lastClr="FFFFFF"/>
          </a:solidFill>
          <a:ln xmlns:a="http://schemas.openxmlformats.org/drawingml/2006/main" w="25400" cap="flat" cmpd="sng" algn="ctr">
            <a:solidFill>
              <a:sysClr val="window" lastClr="FFFFFF"/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1" name="TextBox 2"/>
          <cdr:cNvSpPr txBox="1"/>
        </cdr:nvSpPr>
        <cdr:spPr>
          <a:xfrm xmlns:a="http://schemas.openxmlformats.org/drawingml/2006/main">
            <a:off x="5580112" y="1268760"/>
            <a:ext cx="1150756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Very severe</a:t>
            </a:r>
            <a:endParaRPr lang="en-AU" sz="1600" dirty="0"/>
          </a:p>
        </cdr:txBody>
      </cdr:sp>
      <cdr:sp macro="" textlink="">
        <cdr:nvSpPr>
          <cdr:cNvPr id="12" name="TextBox 3"/>
          <cdr:cNvSpPr txBox="1"/>
        </cdr:nvSpPr>
        <cdr:spPr>
          <a:xfrm xmlns:a="http://schemas.openxmlformats.org/drawingml/2006/main">
            <a:off x="5902721" y="2492896"/>
            <a:ext cx="744303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/>
              <a:t>S</a:t>
            </a:r>
            <a:r>
              <a:rPr lang="en-AU" sz="1600" dirty="0" smtClean="0"/>
              <a:t>evere</a:t>
            </a:r>
            <a:endParaRPr lang="en-AU" sz="1600" dirty="0"/>
          </a:p>
        </cdr:txBody>
      </cdr:sp>
      <cdr:sp macro="" textlink="">
        <cdr:nvSpPr>
          <cdr:cNvPr id="13" name="TextBox 4"/>
          <cdr:cNvSpPr txBox="1"/>
        </cdr:nvSpPr>
        <cdr:spPr>
          <a:xfrm xmlns:a="http://schemas.openxmlformats.org/drawingml/2006/main">
            <a:off x="5759114" y="3573016"/>
            <a:ext cx="1008622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oderate</a:t>
            </a:r>
            <a:endParaRPr lang="en-AU" sz="1600" dirty="0"/>
          </a:p>
        </cdr:txBody>
      </cdr:sp>
      <cdr:sp macro="" textlink="">
        <cdr:nvSpPr>
          <cdr:cNvPr id="14" name="TextBox 6"/>
          <cdr:cNvSpPr txBox="1"/>
        </cdr:nvSpPr>
        <cdr:spPr>
          <a:xfrm xmlns:a="http://schemas.openxmlformats.org/drawingml/2006/main">
            <a:off x="6118131" y="4725144"/>
            <a:ext cx="558179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ild</a:t>
            </a:r>
            <a:endParaRPr lang="en-AU" sz="1600" dirty="0"/>
          </a:p>
        </cdr:txBody>
      </cdr:sp>
      <cdr:sp macro="" textlink="">
        <cdr:nvSpPr>
          <cdr:cNvPr id="15" name="TextBox 7"/>
          <cdr:cNvSpPr txBox="1"/>
        </cdr:nvSpPr>
        <cdr:spPr>
          <a:xfrm xmlns:a="http://schemas.openxmlformats.org/drawingml/2006/main">
            <a:off x="6046328" y="5805264"/>
            <a:ext cx="634904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None</a:t>
            </a:r>
            <a:endParaRPr lang="en-AU" sz="1600" dirty="0"/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/>
          <p:nvPr/>
        </p:nvGraphicFramePr>
        <p:xfrm>
          <a:off x="0" y="1196752"/>
          <a:ext cx="9144000" cy="5661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3" name="Group 12"/>
          <p:cNvGrpSpPr/>
          <p:nvPr/>
        </p:nvGrpSpPr>
        <p:grpSpPr>
          <a:xfrm>
            <a:off x="899592" y="908720"/>
            <a:ext cx="897067" cy="5400600"/>
            <a:chOff x="1902952" y="980728"/>
            <a:chExt cx="889667" cy="5400600"/>
          </a:xfrm>
        </p:grpSpPr>
        <p:sp>
          <p:nvSpPr>
            <p:cNvPr id="14" name="Rectangle 13"/>
            <p:cNvSpPr/>
            <p:nvPr/>
          </p:nvSpPr>
          <p:spPr>
            <a:xfrm>
              <a:off x="1902952" y="980728"/>
              <a:ext cx="826791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974366" y="1268760"/>
              <a:ext cx="7601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Always</a:t>
              </a:r>
              <a:endParaRPr lang="en-AU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117194" y="2348880"/>
              <a:ext cx="5950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Daily</a:t>
              </a:r>
              <a:endParaRPr lang="en-AU" sz="16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979712" y="3501008"/>
              <a:ext cx="7975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Weekly</a:t>
              </a:r>
              <a:endParaRPr lang="en-AU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902952" y="4653136"/>
              <a:ext cx="8896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nthly</a:t>
              </a:r>
              <a:endParaRPr lang="en-AU" sz="16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045780" y="5805264"/>
              <a:ext cx="6849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ever</a:t>
              </a:r>
              <a:endParaRPr lang="en-AU" sz="16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2123728" y="6042774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  <p:grpSp>
        <p:nvGrpSpPr>
          <p:cNvPr id="11" name="Group 10"/>
          <p:cNvGrpSpPr/>
          <p:nvPr/>
        </p:nvGrpSpPr>
        <p:grpSpPr>
          <a:xfrm>
            <a:off x="2483768" y="1268760"/>
            <a:ext cx="1440160" cy="144016"/>
            <a:chOff x="3707904" y="3068960"/>
            <a:chExt cx="2736304" cy="144016"/>
          </a:xfrm>
        </p:grpSpPr>
        <p:cxnSp>
          <p:nvCxnSpPr>
            <p:cNvPr id="19" name="Straight Connector 18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Group 21"/>
          <p:cNvGrpSpPr/>
          <p:nvPr/>
        </p:nvGrpSpPr>
        <p:grpSpPr>
          <a:xfrm>
            <a:off x="2483768" y="980728"/>
            <a:ext cx="2808312" cy="144016"/>
            <a:chOff x="3707904" y="3068960"/>
            <a:chExt cx="2736304" cy="144016"/>
          </a:xfrm>
        </p:grpSpPr>
        <p:cxnSp>
          <p:nvCxnSpPr>
            <p:cNvPr id="23" name="Straight Connector 22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 25"/>
          <p:cNvGrpSpPr/>
          <p:nvPr/>
        </p:nvGrpSpPr>
        <p:grpSpPr>
          <a:xfrm>
            <a:off x="2483768" y="692696"/>
            <a:ext cx="4176464" cy="144016"/>
            <a:chOff x="3707904" y="3068960"/>
            <a:chExt cx="2736304" cy="144016"/>
          </a:xfrm>
        </p:grpSpPr>
        <p:cxnSp>
          <p:nvCxnSpPr>
            <p:cNvPr id="29" name="Straight Connector 28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oup 31"/>
          <p:cNvGrpSpPr/>
          <p:nvPr/>
        </p:nvGrpSpPr>
        <p:grpSpPr>
          <a:xfrm>
            <a:off x="2483768" y="404664"/>
            <a:ext cx="5544616" cy="144016"/>
            <a:chOff x="3707904" y="3068960"/>
            <a:chExt cx="2736304" cy="144016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/>
          <p:cNvGrpSpPr/>
          <p:nvPr/>
        </p:nvGrpSpPr>
        <p:grpSpPr>
          <a:xfrm>
            <a:off x="5148064" y="1782108"/>
            <a:ext cx="1368152" cy="144016"/>
            <a:chOff x="3707904" y="3068960"/>
            <a:chExt cx="2736304" cy="144016"/>
          </a:xfrm>
        </p:grpSpPr>
        <p:cxnSp>
          <p:nvCxnSpPr>
            <p:cNvPr id="41" name="Straight Connector 40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6516216" y="2358172"/>
            <a:ext cx="1296144" cy="144016"/>
            <a:chOff x="3707904" y="3068960"/>
            <a:chExt cx="2736304" cy="144016"/>
          </a:xfrm>
        </p:grpSpPr>
        <p:cxnSp>
          <p:nvCxnSpPr>
            <p:cNvPr id="45" name="Straight Connector 44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TextBox 47"/>
          <p:cNvSpPr txBox="1"/>
          <p:nvPr/>
        </p:nvSpPr>
        <p:spPr>
          <a:xfrm>
            <a:off x="2915816" y="1043444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49" name="TextBox 48"/>
          <p:cNvSpPr txBox="1"/>
          <p:nvPr/>
        </p:nvSpPr>
        <p:spPr>
          <a:xfrm>
            <a:off x="5509845" y="155679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50" name="TextBox 49"/>
          <p:cNvSpPr txBox="1"/>
          <p:nvPr/>
        </p:nvSpPr>
        <p:spPr>
          <a:xfrm>
            <a:off x="6877997" y="2132856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51" name="TextBox 50"/>
          <p:cNvSpPr txBox="1"/>
          <p:nvPr/>
        </p:nvSpPr>
        <p:spPr>
          <a:xfrm>
            <a:off x="3767862" y="755412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52" name="TextBox 51"/>
          <p:cNvSpPr txBox="1"/>
          <p:nvPr/>
        </p:nvSpPr>
        <p:spPr>
          <a:xfrm>
            <a:off x="4141693" y="46738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  <p:sp>
        <p:nvSpPr>
          <p:cNvPr id="53" name="TextBox 52"/>
          <p:cNvSpPr txBox="1"/>
          <p:nvPr/>
        </p:nvSpPr>
        <p:spPr>
          <a:xfrm>
            <a:off x="5005789" y="188640"/>
            <a:ext cx="6463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*</a:t>
            </a:r>
            <a:endParaRPr lang="en-AU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/>
          <p:nvPr/>
        </p:nvGraphicFramePr>
        <p:xfrm>
          <a:off x="0" y="1196752"/>
          <a:ext cx="9144000" cy="56612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 12"/>
          <p:cNvGrpSpPr/>
          <p:nvPr/>
        </p:nvGrpSpPr>
        <p:grpSpPr>
          <a:xfrm>
            <a:off x="899592" y="908720"/>
            <a:ext cx="897067" cy="5400600"/>
            <a:chOff x="1902952" y="980728"/>
            <a:chExt cx="889667" cy="5400600"/>
          </a:xfrm>
        </p:grpSpPr>
        <p:sp>
          <p:nvSpPr>
            <p:cNvPr id="14" name="Rectangle 13"/>
            <p:cNvSpPr/>
            <p:nvPr/>
          </p:nvSpPr>
          <p:spPr>
            <a:xfrm>
              <a:off x="1902952" y="980728"/>
              <a:ext cx="826791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974366" y="1268760"/>
              <a:ext cx="7601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Always</a:t>
              </a:r>
              <a:endParaRPr lang="en-AU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117194" y="2348880"/>
              <a:ext cx="5950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Daily</a:t>
              </a:r>
              <a:endParaRPr lang="en-AU" sz="16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979712" y="3501008"/>
              <a:ext cx="7975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Weekly</a:t>
              </a:r>
              <a:endParaRPr lang="en-AU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902952" y="4653136"/>
              <a:ext cx="8896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nthly</a:t>
              </a:r>
              <a:endParaRPr lang="en-AU" sz="16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045780" y="5805264"/>
              <a:ext cx="6849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ever</a:t>
              </a:r>
              <a:endParaRPr lang="en-AU" sz="16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2123728" y="6042774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/>
        </p:nvGraphicFramePr>
        <p:xfrm>
          <a:off x="-24681" y="0"/>
          <a:ext cx="9168681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755576" y="620688"/>
            <a:ext cx="1499694" cy="5400600"/>
            <a:chOff x="1331640" y="908720"/>
            <a:chExt cx="1499694" cy="5400600"/>
          </a:xfrm>
        </p:grpSpPr>
        <p:sp>
          <p:nvSpPr>
            <p:cNvPr id="10" name="Rectangle 9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979712" y="1196752"/>
              <a:ext cx="76014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Always</a:t>
              </a:r>
              <a:endParaRPr lang="en-AU" sz="16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123728" y="2420888"/>
              <a:ext cx="5950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Daily</a:t>
              </a:r>
              <a:endParaRPr lang="en-AU" sz="16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979712" y="3501008"/>
              <a:ext cx="7975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Weekly</a:t>
              </a:r>
              <a:endParaRPr lang="en-AU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941667" y="4653136"/>
              <a:ext cx="8896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nthly</a:t>
              </a:r>
              <a:endParaRPr lang="en-AU" sz="16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051720" y="5733256"/>
              <a:ext cx="6849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ever</a:t>
              </a:r>
              <a:endParaRPr lang="en-AU" sz="1600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3853292" y="1061120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53</Words>
  <Application>Microsoft Office PowerPoint</Application>
  <PresentationFormat>On-screen Show (4:3)</PresentationFormat>
  <Paragraphs>30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t</dc:creator>
  <cp:lastModifiedBy>Pat</cp:lastModifiedBy>
  <cp:revision>14</cp:revision>
  <dcterms:created xsi:type="dcterms:W3CDTF">2011-11-19T23:44:44Z</dcterms:created>
  <dcterms:modified xsi:type="dcterms:W3CDTF">2012-01-17T00:23:02Z</dcterms:modified>
</cp:coreProperties>
</file>